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5">
  <p:sldMasterIdLst>
    <p:sldMasterId id="2147483648" r:id="rId1"/>
  </p:sldMasterIdLst>
  <p:notesMasterIdLst>
    <p:notesMasterId r:id="rId3"/>
  </p:notesMasterIdLst>
  <p:sldIdLst>
    <p:sldId id="34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18CDF"/>
    <a:srgbClr val="16A8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749" autoAdjust="0"/>
    <p:restoredTop sz="88454" autoAdjust="0"/>
  </p:normalViewPr>
  <p:slideViewPr>
    <p:cSldViewPr>
      <p:cViewPr varScale="1">
        <p:scale>
          <a:sx n="85" d="100"/>
          <a:sy n="85" d="100"/>
        </p:scale>
        <p:origin x="2886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2FAFD0-EF8C-554B-B034-4442DE591FA0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B1FB10-D472-764B-87F9-C134BDEA3E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1839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81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4337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8408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8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8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487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8122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3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0949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7935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5369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91372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465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1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7" y="36408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10" y="191348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1396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8140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1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4334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C56B313E-6D17-DB28-54E3-180A3170663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99670210"/>
              </p:ext>
            </p:extLst>
          </p:nvPr>
        </p:nvGraphicFramePr>
        <p:xfrm>
          <a:off x="762000" y="838200"/>
          <a:ext cx="5210818" cy="571499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410975">
                  <a:extLst>
                    <a:ext uri="{9D8B030D-6E8A-4147-A177-3AD203B41FA5}">
                      <a16:colId xmlns:a16="http://schemas.microsoft.com/office/drawing/2014/main" val="1722815491"/>
                    </a:ext>
                  </a:extLst>
                </a:gridCol>
                <a:gridCol w="2799843">
                  <a:extLst>
                    <a:ext uri="{9D8B030D-6E8A-4147-A177-3AD203B41FA5}">
                      <a16:colId xmlns:a16="http://schemas.microsoft.com/office/drawing/2014/main" val="2774889305"/>
                    </a:ext>
                  </a:extLst>
                </a:gridCol>
              </a:tblGrid>
              <a:tr h="408614">
                <a:tc>
                  <a:txBody>
                    <a:bodyPr/>
                    <a:lstStyle/>
                    <a:p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eptor/Channe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ibition/activate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64407506"/>
                  </a:ext>
                </a:extLst>
              </a:tr>
              <a:tr h="408614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2(h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03539868"/>
                  </a:ext>
                </a:extLst>
              </a:tr>
              <a:tr h="408614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(h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9637028"/>
                  </a:ext>
                </a:extLst>
              </a:tr>
              <a:tr h="408614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(h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88362644"/>
                  </a:ext>
                </a:extLst>
              </a:tr>
              <a:tr h="408614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3(h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05588440"/>
                  </a:ext>
                </a:extLst>
              </a:tr>
              <a:tr h="408614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appa(KOP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37950676"/>
                  </a:ext>
                </a:extLst>
              </a:tr>
              <a:tr h="403017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(MOP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97511947"/>
                  </a:ext>
                </a:extLst>
              </a:tr>
              <a:tr h="408614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-HT1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82960462"/>
                  </a:ext>
                </a:extLst>
              </a:tr>
              <a:tr h="408614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-HT2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12354147"/>
                  </a:ext>
                </a:extLst>
              </a:tr>
              <a:tr h="408614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-HT2B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77443538"/>
                  </a:ext>
                </a:extLst>
              </a:tr>
              <a:tr h="408614">
                <a:tc>
                  <a:txBody>
                    <a:bodyPr/>
                    <a:lstStyle/>
                    <a:p>
                      <a:r>
                        <a:rPr lang="en-US" sz="11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RG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hanne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48444887"/>
                  </a:ext>
                </a:extLst>
              </a:tr>
              <a:tr h="408614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+ channel(site2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34374490"/>
                  </a:ext>
                </a:extLst>
              </a:tr>
              <a:tr h="408614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pamine transporter (h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23843606"/>
                  </a:ext>
                </a:extLst>
              </a:tr>
              <a:tr h="408614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-HT transporter (h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88014479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710E6A5D-DC46-4102-8958-7CE8D4F78840}"/>
              </a:ext>
            </a:extLst>
          </p:cNvPr>
          <p:cNvSpPr txBox="1"/>
          <p:nvPr/>
        </p:nvSpPr>
        <p:spPr>
          <a:xfrm>
            <a:off x="580382" y="407313"/>
            <a:ext cx="5697236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5. </a:t>
            </a:r>
            <a:r>
              <a:rPr lang="en-US" sz="11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erep</a:t>
            </a:r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afety Screen 44 panel for C458 treatment (10mM).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27733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50712</TotalTime>
  <Words>92</Words>
  <Application>Microsoft Office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gey A Trushin</dc:creator>
  <cp:lastModifiedBy>Trushin, Sergey A., Ph.D.</cp:lastModifiedBy>
  <cp:revision>604</cp:revision>
  <cp:lastPrinted>2022-11-09T15:46:24Z</cp:lastPrinted>
  <dcterms:created xsi:type="dcterms:W3CDTF">2020-01-31T17:27:01Z</dcterms:created>
  <dcterms:modified xsi:type="dcterms:W3CDTF">2025-02-12T20:42:09Z</dcterms:modified>
</cp:coreProperties>
</file>